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116" d="100"/>
          <a:sy n="116" d="100"/>
        </p:scale>
        <p:origin x="8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rypotou, Aimilia" userId="3383a474-3fc2-4c30-947f-c16ae8f712c0" providerId="ADAL" clId="{4F2104F2-EA36-324C-8BDE-E6ABB1A70260}"/>
    <pc:docChg chg="delSld">
      <pc:chgData name="Krypotou, Aimilia" userId="3383a474-3fc2-4c30-947f-c16ae8f712c0" providerId="ADAL" clId="{4F2104F2-EA36-324C-8BDE-E6ABB1A70260}" dt="2025-12-29T17:55:49.434" v="7" actId="2696"/>
      <pc:docMkLst>
        <pc:docMk/>
      </pc:docMkLst>
      <pc:sldChg chg="del">
        <pc:chgData name="Krypotou, Aimilia" userId="3383a474-3fc2-4c30-947f-c16ae8f712c0" providerId="ADAL" clId="{4F2104F2-EA36-324C-8BDE-E6ABB1A70260}" dt="2025-12-29T17:55:41.077" v="0" actId="2696"/>
        <pc:sldMkLst>
          <pc:docMk/>
          <pc:sldMk cId="3552300620" sldId="256"/>
        </pc:sldMkLst>
      </pc:sldChg>
      <pc:sldChg chg="del">
        <pc:chgData name="Krypotou, Aimilia" userId="3383a474-3fc2-4c30-947f-c16ae8f712c0" providerId="ADAL" clId="{4F2104F2-EA36-324C-8BDE-E6ABB1A70260}" dt="2025-12-29T17:55:41.580" v="1" actId="2696"/>
        <pc:sldMkLst>
          <pc:docMk/>
          <pc:sldMk cId="2809017152" sldId="257"/>
        </pc:sldMkLst>
      </pc:sldChg>
      <pc:sldChg chg="del">
        <pc:chgData name="Krypotou, Aimilia" userId="3383a474-3fc2-4c30-947f-c16ae8f712c0" providerId="ADAL" clId="{4F2104F2-EA36-324C-8BDE-E6ABB1A70260}" dt="2025-12-29T17:55:42.016" v="2" actId="2696"/>
        <pc:sldMkLst>
          <pc:docMk/>
          <pc:sldMk cId="3412642638" sldId="258"/>
        </pc:sldMkLst>
      </pc:sldChg>
      <pc:sldChg chg="del">
        <pc:chgData name="Krypotou, Aimilia" userId="3383a474-3fc2-4c30-947f-c16ae8f712c0" providerId="ADAL" clId="{4F2104F2-EA36-324C-8BDE-E6ABB1A70260}" dt="2025-12-29T17:55:45.212" v="3" actId="2696"/>
        <pc:sldMkLst>
          <pc:docMk/>
          <pc:sldMk cId="2404163418" sldId="261"/>
        </pc:sldMkLst>
      </pc:sldChg>
      <pc:sldChg chg="del">
        <pc:chgData name="Krypotou, Aimilia" userId="3383a474-3fc2-4c30-947f-c16ae8f712c0" providerId="ADAL" clId="{4F2104F2-EA36-324C-8BDE-E6ABB1A70260}" dt="2025-12-29T17:55:46.003" v="4" actId="2696"/>
        <pc:sldMkLst>
          <pc:docMk/>
          <pc:sldMk cId="3624173451" sldId="262"/>
        </pc:sldMkLst>
      </pc:sldChg>
      <pc:sldChg chg="del">
        <pc:chgData name="Krypotou, Aimilia" userId="3383a474-3fc2-4c30-947f-c16ae8f712c0" providerId="ADAL" clId="{4F2104F2-EA36-324C-8BDE-E6ABB1A70260}" dt="2025-12-29T17:55:47.419" v="5" actId="2696"/>
        <pc:sldMkLst>
          <pc:docMk/>
          <pc:sldMk cId="2855954256" sldId="263"/>
        </pc:sldMkLst>
      </pc:sldChg>
      <pc:sldChg chg="del">
        <pc:chgData name="Krypotou, Aimilia" userId="3383a474-3fc2-4c30-947f-c16ae8f712c0" providerId="ADAL" clId="{4F2104F2-EA36-324C-8BDE-E6ABB1A70260}" dt="2025-12-29T17:55:48.434" v="6" actId="2696"/>
        <pc:sldMkLst>
          <pc:docMk/>
          <pc:sldMk cId="953867029" sldId="264"/>
        </pc:sldMkLst>
      </pc:sldChg>
      <pc:sldChg chg="del">
        <pc:chgData name="Krypotou, Aimilia" userId="3383a474-3fc2-4c30-947f-c16ae8f712c0" providerId="ADAL" clId="{4F2104F2-EA36-324C-8BDE-E6ABB1A70260}" dt="2025-12-29T17:55:49.434" v="7" actId="2696"/>
        <pc:sldMkLst>
          <pc:docMk/>
          <pc:sldMk cId="3450662349" sldId="265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039B4D-ECF8-792D-1E8E-DF17ECEED5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D0879E-100B-DECF-ADC4-DD144A9F53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17B0E5-B386-FA8C-5E4D-D1C5BF27B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5C8D2-18BF-6595-722E-6999D7A36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2F598-7557-0892-70CE-037BE38C9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16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9735B9-A882-17DE-166E-1FFC527ED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95B352-0CB7-C535-D0A0-BC54E1A56D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903C03-7066-EBE1-1117-4E84E2D84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1619AD-FEE7-1E7C-46DE-0FE11435E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900E21-AE59-584E-7CB2-61FC62D50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694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B058CB-508B-7C04-5F5D-165C615F30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4EE964-EC5F-1496-5CE4-A672AE858A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09E7AE-59BD-B6A7-2DE5-B720CDD64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45B330-05E5-99FB-0CA9-A7ABDE40F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9482F0-523B-58BB-D7B0-F9044F67B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862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731038-98AD-FC0F-B704-751CF229D8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AF3291-B390-0786-33A3-CFDB085817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44927B-6AC0-2DEB-AE94-7CA7419E7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8DE34D-7DD7-54E8-A497-8DDE42296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54AF8E-1C5E-75CC-323B-31B1E01C1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FFB8A-E374-BC4D-7A8B-7300C78D5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95A331-2912-E524-05E2-0F6E4A65B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92109-A65E-FBCC-7828-B5B8B5E09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D297F6-7F01-7243-AB92-3F1929F38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98FB16-81D5-5FE7-DFC5-DCCD5D8E5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897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F1EEE-0322-6F4E-76BA-966DD2197F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046413-ABAD-9B9F-6E90-2136C73EF3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CCB1C5-26ED-762B-589D-0A29D69A52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9FA54-F6D7-96A7-5C81-5AAA11200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6AB86B-673B-D28A-5501-AD67EFB74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6AF430-F379-5012-0955-9A6C42F54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379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4A211F-1FAA-0E9E-4E93-9D596DC6F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3BA49A-7628-A281-B85B-499DADD6D1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FA5670-B4A0-74D4-66B0-88CF9F2723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AF9B0AF-10FC-1265-A51C-9F68991AE1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4707EC-24D8-84D4-C76E-AEE7DF571C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FF2908-DCD4-2604-0388-8E7AFF8D1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C54A6C-1F79-4262-6103-698FBAC93B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57B865-B32C-25E7-8180-3E3912AB3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750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06E56-0866-6FAB-15C3-FC50CEED47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B36E4A-366D-B46F-E3A6-32ADFC459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4B04D4-8C00-3F8A-1750-0BEFBEC4D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2AD13E-4F97-AA98-E7E0-808211240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71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E0B539-3FD6-D832-DB3E-0B793AEA4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28AD91-3200-ECA6-A1B1-95D01552D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0CFF6B-067B-5DC6-F9CB-3B837B741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983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F1A002-F5AB-6B48-2E07-B610C66BF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961A05-5520-38A9-5BFC-CE245ECBB3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50FDCE-7FF9-762F-2B0E-2D6A830C31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5CCA21-BC9B-7F6B-8196-F4501BB73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E904E3-882B-C825-D389-1037BC0F3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CBEC86-FB13-F957-46C1-ECD34AD5B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885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EC99E-E26C-F422-1CE4-B16CF38EC9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4728B2-D16D-9B9D-32F6-34ABAA451C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157CE5-0FDC-489A-8472-CC0C9411E1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B9FF73-8F4D-C276-0B53-1F8DFFA26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F63DC4-639C-A347-5BE9-41CEEA2E0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0B7E76-6F50-1272-E45E-779FFC750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89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CB923C-6F2D-B027-721B-FF049C83D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6A7E17-8CE2-2D48-E320-11053EAD0A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D5C985-63C8-D967-1940-EFFB825508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07093-3A49-1398-E7D3-63464BED73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812A23-3A34-9736-5C1E-11D8A5FB94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777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F0D990C-1EBB-5C60-A83A-842B7C6BBA3B}"/>
              </a:ext>
            </a:extLst>
          </p:cNvPr>
          <p:cNvSpPr txBox="1"/>
          <p:nvPr/>
        </p:nvSpPr>
        <p:spPr>
          <a:xfrm>
            <a:off x="625033" y="358815"/>
            <a:ext cx="3205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D mutants with </a:t>
            </a:r>
            <a:r>
              <a:rPr lang="en-US" dirty="0" err="1"/>
              <a:t>ppGpp</a:t>
            </a:r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7BAC4AC-C293-C7CC-1447-24F287660A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8726" y="1746429"/>
            <a:ext cx="2172275" cy="3365142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9500647E-7764-D47B-13A7-D647BF36F51F}"/>
              </a:ext>
            </a:extLst>
          </p:cNvPr>
          <p:cNvCxnSpPr>
            <a:cxnSpLocks/>
          </p:cNvCxnSpPr>
          <p:nvPr/>
        </p:nvCxnSpPr>
        <p:spPr>
          <a:xfrm>
            <a:off x="2277647" y="1735566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5C5008B6-CCF0-D528-EAAC-69C2DBC93E66}"/>
              </a:ext>
            </a:extLst>
          </p:cNvPr>
          <p:cNvSpPr txBox="1"/>
          <p:nvPr/>
        </p:nvSpPr>
        <p:spPr>
          <a:xfrm>
            <a:off x="2280052" y="1377097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F1A84D2-A31A-7CBC-20AA-A3B0095CBAA4}"/>
              </a:ext>
            </a:extLst>
          </p:cNvPr>
          <p:cNvSpPr txBox="1"/>
          <p:nvPr/>
        </p:nvSpPr>
        <p:spPr>
          <a:xfrm>
            <a:off x="820016" y="1958724"/>
            <a:ext cx="1417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70C901B-9180-C597-E88C-79D91170C8EA}"/>
              </a:ext>
            </a:extLst>
          </p:cNvPr>
          <p:cNvSpPr txBox="1"/>
          <p:nvPr/>
        </p:nvSpPr>
        <p:spPr>
          <a:xfrm>
            <a:off x="682158" y="2438299"/>
            <a:ext cx="1555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IDR Rh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9DC330-A587-4EC8-D88D-D83D874CC10C}"/>
              </a:ext>
            </a:extLst>
          </p:cNvPr>
          <p:cNvSpPr txBox="1"/>
          <p:nvPr/>
        </p:nvSpPr>
        <p:spPr>
          <a:xfrm>
            <a:off x="648495" y="2935679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1010EA4-D020-259E-5CFB-5A5DAAF4DC43}"/>
              </a:ext>
            </a:extLst>
          </p:cNvPr>
          <p:cNvSpPr txBox="1"/>
          <p:nvPr/>
        </p:nvSpPr>
        <p:spPr>
          <a:xfrm>
            <a:off x="550711" y="3404468"/>
            <a:ext cx="1686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rich</a:t>
            </a:r>
            <a:r>
              <a:rPr lang="en-US" dirty="0"/>
              <a:t> Rh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D6AF067-A590-B036-25D0-399CE535EC48}"/>
              </a:ext>
            </a:extLst>
          </p:cNvPr>
          <p:cNvSpPr txBox="1"/>
          <p:nvPr/>
        </p:nvSpPr>
        <p:spPr>
          <a:xfrm>
            <a:off x="649723" y="3888013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.5</a:t>
            </a:r>
            <a:r>
              <a:rPr lang="el-GR" dirty="0"/>
              <a:t>μ</a:t>
            </a:r>
            <a:r>
              <a:rPr lang="en-US" dirty="0"/>
              <a:t>M IDR Rh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17B3152-76F0-12B0-F2EE-8A84C64DBC76}"/>
              </a:ext>
            </a:extLst>
          </p:cNvPr>
          <p:cNvSpPr txBox="1"/>
          <p:nvPr/>
        </p:nvSpPr>
        <p:spPr>
          <a:xfrm>
            <a:off x="-152901" y="4285155"/>
            <a:ext cx="243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Binding buffer only -c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9A4071A-71F1-D911-E80F-39B005A63345}"/>
              </a:ext>
            </a:extLst>
          </p:cNvPr>
          <p:cNvSpPr txBox="1"/>
          <p:nvPr/>
        </p:nvSpPr>
        <p:spPr>
          <a:xfrm>
            <a:off x="447157" y="5165842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Rep 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1A35773-D1E5-62E5-FD56-8038FB961BF9}"/>
              </a:ext>
            </a:extLst>
          </p:cNvPr>
          <p:cNvSpPr txBox="1"/>
          <p:nvPr/>
        </p:nvSpPr>
        <p:spPr>
          <a:xfrm>
            <a:off x="8634167" y="5185228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Rep 2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660CD37B-FF39-D686-9640-C3D985E52E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425482">
            <a:off x="8026417" y="1632630"/>
            <a:ext cx="2108810" cy="3478941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83BF71C6-C0B2-FB24-E5DB-46A0FB6A98AE}"/>
              </a:ext>
            </a:extLst>
          </p:cNvPr>
          <p:cNvCxnSpPr>
            <a:cxnSpLocks/>
          </p:cNvCxnSpPr>
          <p:nvPr/>
        </p:nvCxnSpPr>
        <p:spPr>
          <a:xfrm>
            <a:off x="8089147" y="1790549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EED7809E-536A-FE52-E2C2-8762CBCD43A9}"/>
              </a:ext>
            </a:extLst>
          </p:cNvPr>
          <p:cNvSpPr txBox="1"/>
          <p:nvPr/>
        </p:nvSpPr>
        <p:spPr>
          <a:xfrm>
            <a:off x="8091552" y="1432080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1E1C718-FA5F-C2EA-1E32-B41DAE7CEE79}"/>
              </a:ext>
            </a:extLst>
          </p:cNvPr>
          <p:cNvSpPr txBox="1"/>
          <p:nvPr/>
        </p:nvSpPr>
        <p:spPr>
          <a:xfrm>
            <a:off x="6354914" y="1926357"/>
            <a:ext cx="1534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7FD8E8F-1E1F-D381-1A3A-1919CD91802D}"/>
              </a:ext>
            </a:extLst>
          </p:cNvPr>
          <p:cNvSpPr txBox="1"/>
          <p:nvPr/>
        </p:nvSpPr>
        <p:spPr>
          <a:xfrm>
            <a:off x="6217056" y="2405932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IDR Rh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BE22E00-5F3B-1C24-CA38-0C3BD59E96B6}"/>
              </a:ext>
            </a:extLst>
          </p:cNvPr>
          <p:cNvSpPr txBox="1"/>
          <p:nvPr/>
        </p:nvSpPr>
        <p:spPr>
          <a:xfrm>
            <a:off x="6183393" y="2903312"/>
            <a:ext cx="1705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082CB9A-3F66-10F8-EC60-02A50F88E9A5}"/>
              </a:ext>
            </a:extLst>
          </p:cNvPr>
          <p:cNvSpPr txBox="1"/>
          <p:nvPr/>
        </p:nvSpPr>
        <p:spPr>
          <a:xfrm>
            <a:off x="6085608" y="3372101"/>
            <a:ext cx="180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rich</a:t>
            </a:r>
            <a:r>
              <a:rPr lang="en-US" dirty="0"/>
              <a:t> Rh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C557597-447B-AD9C-96FB-3632F77F5A30}"/>
              </a:ext>
            </a:extLst>
          </p:cNvPr>
          <p:cNvSpPr txBox="1"/>
          <p:nvPr/>
        </p:nvSpPr>
        <p:spPr>
          <a:xfrm>
            <a:off x="6301640" y="3855646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.5</a:t>
            </a:r>
            <a:r>
              <a:rPr lang="el-GR" dirty="0"/>
              <a:t>μ</a:t>
            </a:r>
            <a:r>
              <a:rPr lang="en-US" dirty="0"/>
              <a:t>M IDR Rho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525315E-DB8B-7F40-BF75-3F7027C52ADC}"/>
              </a:ext>
            </a:extLst>
          </p:cNvPr>
          <p:cNvSpPr txBox="1"/>
          <p:nvPr/>
        </p:nvSpPr>
        <p:spPr>
          <a:xfrm>
            <a:off x="5499016" y="4252788"/>
            <a:ext cx="243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Binding buffer only -con</a:t>
            </a:r>
          </a:p>
        </p:txBody>
      </p:sp>
    </p:spTree>
    <p:extLst>
      <p:ext uri="{BB962C8B-B14F-4D97-AF65-F5344CB8AC3E}">
        <p14:creationId xmlns:p14="http://schemas.microsoft.com/office/powerpoint/2010/main" val="19398674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B80B53CB-DD03-1552-E030-87D2DAA5DD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1367" y="1708894"/>
            <a:ext cx="2016459" cy="3005374"/>
          </a:xfrm>
          <a:prstGeom prst="rect">
            <a:avLst/>
          </a:prstGeom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D9CF7D4-FC91-E854-ED32-B8F4CEB022B6}"/>
              </a:ext>
            </a:extLst>
          </p:cNvPr>
          <p:cNvCxnSpPr>
            <a:cxnSpLocks/>
          </p:cNvCxnSpPr>
          <p:nvPr/>
        </p:nvCxnSpPr>
        <p:spPr>
          <a:xfrm>
            <a:off x="3114894" y="1729487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375F4EDC-0C2D-94FB-3962-C9B3CD1B3103}"/>
              </a:ext>
            </a:extLst>
          </p:cNvPr>
          <p:cNvSpPr txBox="1"/>
          <p:nvPr/>
        </p:nvSpPr>
        <p:spPr>
          <a:xfrm>
            <a:off x="3117299" y="1371018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9F7FFB6-9006-9372-0345-B9B35CEC903F}"/>
              </a:ext>
            </a:extLst>
          </p:cNvPr>
          <p:cNvSpPr txBox="1"/>
          <p:nvPr/>
        </p:nvSpPr>
        <p:spPr>
          <a:xfrm>
            <a:off x="1380661" y="1865295"/>
            <a:ext cx="1534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1696D23-398E-154C-78A6-AF00C35D5E3B}"/>
              </a:ext>
            </a:extLst>
          </p:cNvPr>
          <p:cNvSpPr txBox="1"/>
          <p:nvPr/>
        </p:nvSpPr>
        <p:spPr>
          <a:xfrm>
            <a:off x="1242803" y="2344870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IDR Rh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F3FBD72-659F-0941-E49B-4F48821EDCE3}"/>
              </a:ext>
            </a:extLst>
          </p:cNvPr>
          <p:cNvSpPr txBox="1"/>
          <p:nvPr/>
        </p:nvSpPr>
        <p:spPr>
          <a:xfrm>
            <a:off x="1209140" y="2842250"/>
            <a:ext cx="1705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FF5322-1F5A-1C1A-AF98-8749DF12EF80}"/>
              </a:ext>
            </a:extLst>
          </p:cNvPr>
          <p:cNvSpPr txBox="1"/>
          <p:nvPr/>
        </p:nvSpPr>
        <p:spPr>
          <a:xfrm>
            <a:off x="1111355" y="3311039"/>
            <a:ext cx="180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rich</a:t>
            </a:r>
            <a:r>
              <a:rPr lang="en-US" dirty="0"/>
              <a:t> Rh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15C4BDE-8796-ED5A-EA2E-715E60FC2771}"/>
              </a:ext>
            </a:extLst>
          </p:cNvPr>
          <p:cNvSpPr txBox="1"/>
          <p:nvPr/>
        </p:nvSpPr>
        <p:spPr>
          <a:xfrm>
            <a:off x="1327387" y="3794584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.5</a:t>
            </a:r>
            <a:r>
              <a:rPr lang="el-GR" dirty="0"/>
              <a:t>μ</a:t>
            </a:r>
            <a:r>
              <a:rPr lang="en-US" dirty="0"/>
              <a:t>M IDR Rh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E1E6FC7-F2A9-BECB-8AD4-3B747471D04F}"/>
              </a:ext>
            </a:extLst>
          </p:cNvPr>
          <p:cNvSpPr txBox="1"/>
          <p:nvPr/>
        </p:nvSpPr>
        <p:spPr>
          <a:xfrm>
            <a:off x="524763" y="4191726"/>
            <a:ext cx="243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Binding buffer only -c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4F7C4C5-355B-47B4-7632-8ED0E70E3DC4}"/>
              </a:ext>
            </a:extLst>
          </p:cNvPr>
          <p:cNvSpPr txBox="1"/>
          <p:nvPr/>
        </p:nvSpPr>
        <p:spPr>
          <a:xfrm>
            <a:off x="3775406" y="4783099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Rep 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23DC25B-C504-7E6E-25ED-8C1F156C102D}"/>
              </a:ext>
            </a:extLst>
          </p:cNvPr>
          <p:cNvSpPr txBox="1"/>
          <p:nvPr/>
        </p:nvSpPr>
        <p:spPr>
          <a:xfrm>
            <a:off x="625033" y="358815"/>
            <a:ext cx="3205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D mutants with </a:t>
            </a:r>
            <a:r>
              <a:rPr lang="en-US" dirty="0" err="1"/>
              <a:t>ppGpp</a:t>
            </a:r>
            <a:endParaRPr lang="en-US" dirty="0"/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E9108C9-C0DE-655D-C31E-BBA9C838F0CD}"/>
              </a:ext>
            </a:extLst>
          </p:cNvPr>
          <p:cNvCxnSpPr>
            <a:cxnSpLocks/>
          </p:cNvCxnSpPr>
          <p:nvPr/>
        </p:nvCxnSpPr>
        <p:spPr>
          <a:xfrm>
            <a:off x="8669978" y="1808456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95366AE0-3E75-9AB8-E090-2D8F01ACB510}"/>
              </a:ext>
            </a:extLst>
          </p:cNvPr>
          <p:cNvSpPr txBox="1"/>
          <p:nvPr/>
        </p:nvSpPr>
        <p:spPr>
          <a:xfrm>
            <a:off x="8672383" y="1449987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34BF224-C199-12FD-DAAD-B027CF48B263}"/>
              </a:ext>
            </a:extLst>
          </p:cNvPr>
          <p:cNvSpPr txBox="1"/>
          <p:nvPr/>
        </p:nvSpPr>
        <p:spPr>
          <a:xfrm>
            <a:off x="6935745" y="1944264"/>
            <a:ext cx="1534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8F6FD97-2856-46E9-59A8-5B9839E9170C}"/>
              </a:ext>
            </a:extLst>
          </p:cNvPr>
          <p:cNvSpPr txBox="1"/>
          <p:nvPr/>
        </p:nvSpPr>
        <p:spPr>
          <a:xfrm>
            <a:off x="6797887" y="2423839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IDR Rho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500DEE9-5A66-B56C-C12D-B0333BF3ACE9}"/>
              </a:ext>
            </a:extLst>
          </p:cNvPr>
          <p:cNvSpPr txBox="1"/>
          <p:nvPr/>
        </p:nvSpPr>
        <p:spPr>
          <a:xfrm>
            <a:off x="6764224" y="2921219"/>
            <a:ext cx="1705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F7E9C92-9962-5D52-278F-F0C871A43BB8}"/>
              </a:ext>
            </a:extLst>
          </p:cNvPr>
          <p:cNvSpPr txBox="1"/>
          <p:nvPr/>
        </p:nvSpPr>
        <p:spPr>
          <a:xfrm>
            <a:off x="6666439" y="3390008"/>
            <a:ext cx="180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rich</a:t>
            </a:r>
            <a:r>
              <a:rPr lang="en-US" dirty="0"/>
              <a:t> Rho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19DDF0A-14DD-ED99-F3C3-7100A58B778C}"/>
              </a:ext>
            </a:extLst>
          </p:cNvPr>
          <p:cNvSpPr txBox="1"/>
          <p:nvPr/>
        </p:nvSpPr>
        <p:spPr>
          <a:xfrm>
            <a:off x="6882471" y="3873553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.5</a:t>
            </a:r>
            <a:r>
              <a:rPr lang="el-GR" dirty="0"/>
              <a:t>μ</a:t>
            </a:r>
            <a:r>
              <a:rPr lang="en-US" dirty="0"/>
              <a:t>M IDR Rho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60917DA-885F-BA15-73C5-20A65F6434A2}"/>
              </a:ext>
            </a:extLst>
          </p:cNvPr>
          <p:cNvSpPr txBox="1"/>
          <p:nvPr/>
        </p:nvSpPr>
        <p:spPr>
          <a:xfrm>
            <a:off x="6079847" y="4270695"/>
            <a:ext cx="243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Binding buffer only -con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2D5EDDCD-3005-F5DB-58BA-64D634FF4E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99490" y="1865295"/>
            <a:ext cx="2102790" cy="32305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6765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dd8cbebb-2139-4df8-b411-4e3e87abeb5c}" enabled="0" method="" siteId="{dd8cbebb-2139-4df8-b411-4e3e87abeb5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160</Words>
  <Application>Microsoft Macintosh PowerPoint</Application>
  <PresentationFormat>Widescreen</PresentationFormat>
  <Paragraphs>3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ypotou, Aimilia</dc:creator>
  <cp:lastModifiedBy>Krypotou, Aimilia</cp:lastModifiedBy>
  <cp:revision>1</cp:revision>
  <dcterms:created xsi:type="dcterms:W3CDTF">2025-12-06T18:43:48Z</dcterms:created>
  <dcterms:modified xsi:type="dcterms:W3CDTF">2025-12-29T17:55:51Z</dcterms:modified>
</cp:coreProperties>
</file>